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3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59" d="100"/>
          <a:sy n="59" d="100"/>
        </p:scale>
        <p:origin x="1747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61E0A8A-0570-4501-9B46-27F4AB396C2B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805902-DA43-4C4B-9A90-E5FA32DE47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96397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1AF064C-65AB-4A69-9534-63EE2A54081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3955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5B68C-AB7E-4841-B3C5-390BCECC0611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9B34A-D637-40FF-81C6-316B151A98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80227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5B68C-AB7E-4841-B3C5-390BCECC0611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9B34A-D637-40FF-81C6-316B151A98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46923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5B68C-AB7E-4841-B3C5-390BCECC0611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9B34A-D637-40FF-81C6-316B151A98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1618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5B68C-AB7E-4841-B3C5-390BCECC0611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9B34A-D637-40FF-81C6-316B151A98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74262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>
                    <a:tint val="82000"/>
                  </a:schemeClr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82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82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5B68C-AB7E-4841-B3C5-390BCECC0611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9B34A-D637-40FF-81C6-316B151A98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71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5B68C-AB7E-4841-B3C5-390BCECC0611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9B34A-D637-40FF-81C6-316B151A98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29722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5B68C-AB7E-4841-B3C5-390BCECC0611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9B34A-D637-40FF-81C6-316B151A98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09194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5B68C-AB7E-4841-B3C5-390BCECC0611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9B34A-D637-40FF-81C6-316B151A98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700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5B68C-AB7E-4841-B3C5-390BCECC0611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9B34A-D637-40FF-81C6-316B151A98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28655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5B68C-AB7E-4841-B3C5-390BCECC0611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9B34A-D637-40FF-81C6-316B151A98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48843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5B68C-AB7E-4841-B3C5-390BCECC0611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9B34A-D637-40FF-81C6-316B151A98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49922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B55B68C-AB7E-4841-B3C5-390BCECC0611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709B34A-D637-40FF-81C6-316B151A98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57849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Picture 34">
            <a:extLst>
              <a:ext uri="{FF2B5EF4-FFF2-40B4-BE49-F238E27FC236}">
                <a16:creationId xmlns:a16="http://schemas.microsoft.com/office/drawing/2014/main" id="{CA1E0FC6-DE6D-C34E-A45D-7DE1C8378A1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3925" y="2089234"/>
            <a:ext cx="6304549" cy="226440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4B4E4ED9-88E6-1EF6-F24D-5FF3F93B1CE2}"/>
              </a:ext>
            </a:extLst>
          </p:cNvPr>
          <p:cNvSpPr txBox="1"/>
          <p:nvPr/>
        </p:nvSpPr>
        <p:spPr>
          <a:xfrm>
            <a:off x="1214651" y="4681182"/>
            <a:ext cx="3916907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S1.</a:t>
            </a:r>
            <a:r>
              <a:rPr lang="en-US" dirty="0"/>
              <a:t> PCA plots of study samples and quality control study pools (QCSP) using all peaks from (A) MCF-7 and (B) MDA-MB-231 cells. All multivariate plots were scaled to unit variance.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396287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</TotalTime>
  <Words>45</Words>
  <Application>Microsoft Office PowerPoint</Application>
  <PresentationFormat>Custom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ushing, Blake Richey</dc:creator>
  <cp:lastModifiedBy>Rushing, Blake Richey</cp:lastModifiedBy>
  <cp:revision>2</cp:revision>
  <dcterms:created xsi:type="dcterms:W3CDTF">2025-02-11T16:02:22Z</dcterms:created>
  <dcterms:modified xsi:type="dcterms:W3CDTF">2025-02-11T16:33:43Z</dcterms:modified>
</cp:coreProperties>
</file>